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ddar, Binata" initials="JB" lastIdx="5" clrIdx="0">
    <p:extLst>
      <p:ext uri="{19B8F6BF-5375-455C-9EA6-DF929625EA0E}">
        <p15:presenceInfo xmlns:p15="http://schemas.microsoft.com/office/powerpoint/2012/main" userId="S-1-5-21-24445035-1449287043-316617838-391784" providerId="AD"/>
      </p:ext>
    </p:extLst>
  </p:cmAuthor>
  <p:cmAuthor id="2" name="Nishat Tasnim" initials="NT" lastIdx="1" clrIdx="1">
    <p:extLst>
      <p:ext uri="{19B8F6BF-5375-455C-9EA6-DF929625EA0E}">
        <p15:presenceInfo xmlns:p15="http://schemas.microsoft.com/office/powerpoint/2012/main" userId="Nishat Tasni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32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41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93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671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03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565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886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522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072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177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468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446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BA28C-B2BD-4620-9DB5-AFCCFE6575F3}" type="datetimeFigureOut">
              <a:rPr lang="en-US" smtClean="0"/>
              <a:t>5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6F00C-5A6D-4C42-BA12-868594E40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69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6098" y="-3586"/>
            <a:ext cx="3261627" cy="2995089"/>
            <a:chOff x="2524978" y="1703294"/>
            <a:chExt cx="3261627" cy="299508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F819C35-26D0-47AE-83A6-97E33D6E58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873"/>
            <a:stretch/>
          </p:blipFill>
          <p:spPr>
            <a:xfrm>
              <a:off x="2894363" y="2049773"/>
              <a:ext cx="2892242" cy="26486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2787F33-7940-4609-9F99-F283C3A4BFF6}"/>
                </a:ext>
              </a:extLst>
            </p:cNvPr>
            <p:cNvSpPr txBox="1"/>
            <p:nvPr/>
          </p:nvSpPr>
          <p:spPr>
            <a:xfrm>
              <a:off x="2524978" y="1703294"/>
              <a:ext cx="9869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F17A73D8-FE8D-454A-8291-AA203B5B01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3502" y="342894"/>
            <a:ext cx="3247645" cy="31103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2787F33-7940-4609-9F99-F283C3A4BFF6}"/>
              </a:ext>
            </a:extLst>
          </p:cNvPr>
          <p:cNvSpPr txBox="1"/>
          <p:nvPr/>
        </p:nvSpPr>
        <p:spPr>
          <a:xfrm>
            <a:off x="3553502" y="-3586"/>
            <a:ext cx="1045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724" y="3520862"/>
            <a:ext cx="3254890" cy="311031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26F9866-6CE8-478F-9232-9B741F2C074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01" t="9011" r="11578"/>
          <a:stretch/>
        </p:blipFill>
        <p:spPr>
          <a:xfrm>
            <a:off x="3516092" y="3490382"/>
            <a:ext cx="3285055" cy="3110311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2787F33-7940-4609-9F99-F283C3A4BFF6}"/>
              </a:ext>
            </a:extLst>
          </p:cNvPr>
          <p:cNvSpPr txBox="1"/>
          <p:nvPr/>
        </p:nvSpPr>
        <p:spPr>
          <a:xfrm>
            <a:off x="83650" y="3198172"/>
            <a:ext cx="986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2787F33-7940-4609-9F99-F283C3A4BFF6}"/>
              </a:ext>
            </a:extLst>
          </p:cNvPr>
          <p:cNvSpPr txBox="1"/>
          <p:nvPr/>
        </p:nvSpPr>
        <p:spPr>
          <a:xfrm>
            <a:off x="3352834" y="3210787"/>
            <a:ext cx="1022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132320" y="257629"/>
            <a:ext cx="417576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Material characterization of Pristine Graphene foam.  </a:t>
            </a:r>
          </a:p>
          <a:p>
            <a:pPr marL="342900" indent="-342900" algn="just">
              <a:buAutoNum type="alphaUcParenBoth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ning Electron Microscopy (SEM) image. </a:t>
            </a:r>
          </a:p>
          <a:p>
            <a:pPr marL="342900" indent="-342900" algn="just">
              <a:buAutoNum type="alphaUcParenBoth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rent Voltage (I-V) characteristics.</a:t>
            </a:r>
          </a:p>
          <a:p>
            <a:pPr marL="342900" indent="-342900" algn="just">
              <a:buAutoNum type="alphaUcParenBoth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man and </a:t>
            </a:r>
          </a:p>
          <a:p>
            <a:pPr marL="342900" indent="-342900" algn="just">
              <a:buAutoNum type="alphaUcParenBoth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XRD spectra, respectively.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630E20-EBC0-483D-9A62-77B72240191D}"/>
              </a:ext>
            </a:extLst>
          </p:cNvPr>
          <p:cNvSpPr txBox="1"/>
          <p:nvPr/>
        </p:nvSpPr>
        <p:spPr>
          <a:xfrm rot="16200000">
            <a:off x="2506630" y="4288504"/>
            <a:ext cx="891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77589B2-0A52-4B44-B10F-5673CF422E8D}"/>
              </a:ext>
            </a:extLst>
          </p:cNvPr>
          <p:cNvSpPr txBox="1"/>
          <p:nvPr/>
        </p:nvSpPr>
        <p:spPr>
          <a:xfrm>
            <a:off x="2692663" y="4213205"/>
            <a:ext cx="986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6081E03-B70A-4AB4-87EE-04AB2A35B792}"/>
              </a:ext>
            </a:extLst>
          </p:cNvPr>
          <p:cNvSpPr txBox="1"/>
          <p:nvPr/>
        </p:nvSpPr>
        <p:spPr>
          <a:xfrm rot="16200000">
            <a:off x="805000" y="3865099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8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AA6DCBB-5232-4368-867E-526E447B022C}"/>
              </a:ext>
            </a:extLst>
          </p:cNvPr>
          <p:cNvSpPr txBox="1"/>
          <p:nvPr/>
        </p:nvSpPr>
        <p:spPr>
          <a:xfrm>
            <a:off x="852429" y="3580119"/>
            <a:ext cx="986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78EE86-F9DE-4429-9D3D-30DD42FD5E01}"/>
              </a:ext>
            </a:extLst>
          </p:cNvPr>
          <p:cNvSpPr txBox="1"/>
          <p:nvPr/>
        </p:nvSpPr>
        <p:spPr>
          <a:xfrm>
            <a:off x="4947537" y="3645795"/>
            <a:ext cx="712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02)</a:t>
            </a:r>
          </a:p>
        </p:txBody>
      </p:sp>
    </p:spTree>
    <p:extLst>
      <p:ext uri="{BB962C8B-B14F-4D97-AF65-F5344CB8AC3E}">
        <p14:creationId xmlns:p14="http://schemas.microsoft.com/office/powerpoint/2010/main" val="4143420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3</TotalTime>
  <Words>55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ddar, Binata</dc:creator>
  <cp:lastModifiedBy>Nishat Tasnim</cp:lastModifiedBy>
  <cp:revision>69</cp:revision>
  <dcterms:created xsi:type="dcterms:W3CDTF">2017-11-07T18:52:12Z</dcterms:created>
  <dcterms:modified xsi:type="dcterms:W3CDTF">2018-05-22T17:14:36Z</dcterms:modified>
</cp:coreProperties>
</file>